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50D0FA7-1383-41E0-9B94-79712B03D5B0}" v="5" dt="2021-04-30T15:02:47.3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4660"/>
  </p:normalViewPr>
  <p:slideViewPr>
    <p:cSldViewPr snapToGrid="0">
      <p:cViewPr varScale="1">
        <p:scale>
          <a:sx n="80" d="100"/>
          <a:sy n="80" d="100"/>
        </p:scale>
        <p:origin x="296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4437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04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8482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6197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6090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3447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773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2842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6077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2707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2109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94DE9-5EE4-453A-9165-498A488EA427}" type="datetimeFigureOut">
              <a:rPr lang="es-ES" smtClean="0"/>
              <a:t>06/05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2178F-12F4-4074-8CF6-94DE469A8E3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8906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675900" y="1249622"/>
            <a:ext cx="5617534" cy="1615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s-E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Supplementary Material</a:t>
            </a:r>
            <a:endParaRPr kumimoji="0" lang="es-ES" altLang="es-E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Primers and probe, reaction mix, thermal cycling conditions and calibration curve used to detect and quantify </a:t>
            </a:r>
            <a:r>
              <a:rPr kumimoji="0" lang="en-GB" altLang="es-E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HCoV</a:t>
            </a:r>
            <a:r>
              <a:rPr kumimoji="0" lang="en-GB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 229-E. </a:t>
            </a:r>
            <a:endParaRPr kumimoji="0" lang="es-ES" altLang="es-E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Reaction mix (10 µL) consisted of 5·00 µL 2X One Step RT-PCR Buffer III, 0·20 µL </a:t>
            </a:r>
            <a:r>
              <a:rPr kumimoji="0" lang="en-GB" altLang="es-E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PrimeScript</a:t>
            </a:r>
            <a:r>
              <a:rPr kumimoji="0" lang="en-GB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 RT enzyme Mix II, 0·20 µL ROX, 0·20 mL </a:t>
            </a:r>
            <a:r>
              <a:rPr kumimoji="0" lang="en-GB" altLang="es-E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TaKaRa</a:t>
            </a:r>
            <a:r>
              <a:rPr kumimoji="0" lang="en-GB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 Ex </a:t>
            </a:r>
            <a:r>
              <a:rPr kumimoji="0" lang="en-GB" altLang="es-E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Taq</a:t>
            </a:r>
            <a:r>
              <a:rPr kumimoji="0" lang="en-GB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itchFamily="34" charset="0"/>
                <a:cs typeface="Calibri" panose="020F0502020204030204" pitchFamily="34" charset="0"/>
              </a:rPr>
              <a:t> HS, 0·30 µL 229E-F and 229E-R primers (10mM), 0·15 µL 229E-P probe (10mM). The cycling parameters were as RT at 48 °C for 30 min, preheating at 95 °C for 10 min and 45 cycles of amplification at 95 °C for 15 s, and 60 °C for 1 min.</a:t>
            </a:r>
            <a:endParaRPr kumimoji="0" lang="es-ES" altLang="es-E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altLang="es-E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25" name="Immagin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7408" y="3753650"/>
            <a:ext cx="3406616" cy="21985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6 CuadroTexto"/>
          <p:cNvSpPr txBox="1"/>
          <p:nvPr/>
        </p:nvSpPr>
        <p:spPr>
          <a:xfrm>
            <a:off x="1207034" y="6152350"/>
            <a:ext cx="5268686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altLang="es-ES" sz="11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</a:t>
            </a:r>
            <a:r>
              <a:rPr lang="en-GB" altLang="es-E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tandard curve generated to quantify </a:t>
            </a:r>
            <a:r>
              <a:rPr lang="en-GB" altLang="es-ES" sz="1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CoV</a:t>
            </a:r>
            <a:r>
              <a:rPr lang="en-GB" altLang="es-E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229-E performed with 10-fold dilutions (10</a:t>
            </a:r>
            <a:r>
              <a:rPr lang="en-GB" altLang="es-ES" sz="11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  <a:r>
              <a:rPr lang="en-GB" altLang="es-E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10</a:t>
            </a:r>
            <a:r>
              <a:rPr lang="en-GB" altLang="es-ES" sz="11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</a:t>
            </a:r>
            <a:r>
              <a:rPr lang="en-GB" altLang="es-E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altLang="es-ES" sz="1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c</a:t>
            </a:r>
            <a:r>
              <a:rPr lang="en-GB" altLang="es-ES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reaction) of genomic RNA.</a:t>
            </a:r>
          </a:p>
          <a:p>
            <a:pPr lvl="0"/>
            <a:endParaRPr lang="en-GB" altLang="es-E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lvl="0"/>
            <a:endParaRPr lang="en-GB" altLang="es-E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s-E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7033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A1796A5E-2E55-4940-8D7C-23B01CDDF6B5}"/>
              </a:ext>
            </a:extLst>
          </p:cNvPr>
          <p:cNvSpPr txBox="1"/>
          <p:nvPr/>
        </p:nvSpPr>
        <p:spPr>
          <a:xfrm>
            <a:off x="1451944" y="4625117"/>
            <a:ext cx="45459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SI Figure 2: 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Serial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dilutions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of pre-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pandemic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Controls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to determine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cut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-off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values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order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to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discriminate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between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negative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and positive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in COVID -19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collected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breastmilk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calculated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as </a:t>
            </a:r>
            <a:r>
              <a:rPr lang="es-E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es-ES" sz="1100" dirty="0">
                <a:latin typeface="Calibri" panose="020F0502020204030204" pitchFamily="34" charset="0"/>
                <a:cs typeface="Calibri" panose="020F0502020204030204" pitchFamily="34" charset="0"/>
              </a:rPr>
              <a:t> mean ± 2SD</a:t>
            </a:r>
          </a:p>
        </p:txBody>
      </p:sp>
      <p:pic>
        <p:nvPicPr>
          <p:cNvPr id="2" name="1 Imagen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5894" y="2981739"/>
            <a:ext cx="5505772" cy="14615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0780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3 Imagen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606" y="1661785"/>
            <a:ext cx="4970970" cy="2577741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4C0B7E2D-64E5-43C2-A7B0-C492DA0B577E}"/>
              </a:ext>
            </a:extLst>
          </p:cNvPr>
          <p:cNvSpPr txBox="1"/>
          <p:nvPr/>
        </p:nvSpPr>
        <p:spPr>
          <a:xfrm>
            <a:off x="739302" y="4625117"/>
            <a:ext cx="550247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>
                <a:latin typeface="Calibri" panose="020F0502020204030204" pitchFamily="34" charset="0"/>
                <a:cs typeface="Calibri" panose="020F0502020204030204" pitchFamily="34" charset="0"/>
              </a:rPr>
              <a:t>SI Figure 3: 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Reactivity of human milk samples from asymptomatic and symptomatic  COVID-19 infected and/or recovered mothers to RBD antigen.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C were calculated from titration curves for RBD-reactive (a) IgA, (b) IgM and (c) IgG in order to get a better graphical impression. </a:t>
            </a:r>
            <a:endParaRPr lang="es-E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79467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3</TotalTime>
  <Words>234</Words>
  <Application>Microsoft Office PowerPoint</Application>
  <PresentationFormat>A4 (210 x 297 mm)</PresentationFormat>
  <Paragraphs>7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hris</dc:creator>
  <cp:lastModifiedBy>MCOLAM</cp:lastModifiedBy>
  <cp:revision>9</cp:revision>
  <dcterms:created xsi:type="dcterms:W3CDTF">2021-04-05T09:07:34Z</dcterms:created>
  <dcterms:modified xsi:type="dcterms:W3CDTF">2021-05-06T16:08:19Z</dcterms:modified>
</cp:coreProperties>
</file>